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10.jpeg" ContentType="image/jpeg"/>
  <Override PartName="/ppt/media/image6.jpeg" ContentType="image/jpeg"/>
  <Override PartName="/ppt/media/image11.jpeg" ContentType="image/jpeg"/>
  <Override PartName="/ppt/media/image7.jpeg" ContentType="image/jpeg"/>
  <Override PartName="/ppt/media/image8.jpeg" ContentType="image/jpeg"/>
  <Override PartName="/ppt/media/image9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98ECA5-780A-4AA3-B8F0-DA00F4A3C3A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5D8D59-82F0-44AC-9891-02460742D9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0AD036-6645-4898-A689-2DF61FFEC97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3E5382-4C51-45E1-9D46-06DF785ABF8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0DFE20-23A7-4048-8895-84AED9B16B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683172-71B4-4506-A57F-D4D5E8FAB8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C45FC0-52CC-47C8-8A7F-485B36F508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38AAC6-7170-43EB-8CCB-23F74C6ACF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D0CD9C-9A14-4809-BB16-45FFCF2338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842370-B826-4918-AB17-85B78D69F1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767BC8-C4CD-4550-B489-A96C196C32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B5430B-6074-462C-8D7E-B76A73666D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145ED4-E126-4CDF-B552-273C45DF875F}" type="slidenum">
              <a:rPr b="0" lang="es-E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258920" y="2741760"/>
            <a:ext cx="1152360" cy="15667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2467080" y="2741760"/>
            <a:ext cx="1150920" cy="15667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1262160" y="4356000"/>
            <a:ext cx="1150920" cy="15685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44" name="" descr=""/>
          <p:cNvPicPr/>
          <p:nvPr/>
        </p:nvPicPr>
        <p:blipFill>
          <a:blip r:embed="rId4"/>
          <a:stretch/>
        </p:blipFill>
        <p:spPr>
          <a:xfrm>
            <a:off x="2468520" y="4356000"/>
            <a:ext cx="1150920" cy="15670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45" name="" descr=""/>
          <p:cNvPicPr/>
          <p:nvPr/>
        </p:nvPicPr>
        <p:blipFill>
          <a:blip r:embed="rId5"/>
          <a:stretch/>
        </p:blipFill>
        <p:spPr>
          <a:xfrm>
            <a:off x="2468520" y="1125360"/>
            <a:ext cx="1150920" cy="15685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grpSp>
        <p:nvGrpSpPr>
          <p:cNvPr id="46" name=""/>
          <p:cNvGrpSpPr/>
          <p:nvPr/>
        </p:nvGrpSpPr>
        <p:grpSpPr>
          <a:xfrm>
            <a:off x="1258920" y="1125360"/>
            <a:ext cx="1152360" cy="1568160"/>
            <a:chOff x="1258920" y="1125360"/>
            <a:chExt cx="1152360" cy="1568160"/>
          </a:xfrm>
        </p:grpSpPr>
        <p:pic>
          <p:nvPicPr>
            <p:cNvPr id="47" name="" descr=""/>
            <p:cNvPicPr/>
            <p:nvPr/>
          </p:nvPicPr>
          <p:blipFill>
            <a:blip r:embed="rId6">
              <a:lum bright="20000"/>
            </a:blip>
            <a:stretch/>
          </p:blipFill>
          <p:spPr>
            <a:xfrm>
              <a:off x="1258920" y="1125360"/>
              <a:ext cx="639720" cy="15681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pic>
          <p:nvPicPr>
            <p:cNvPr id="48" name="" descr=""/>
            <p:cNvPicPr/>
            <p:nvPr/>
          </p:nvPicPr>
          <p:blipFill>
            <a:blip r:embed="rId7">
              <a:lum bright="20000"/>
            </a:blip>
            <a:stretch/>
          </p:blipFill>
          <p:spPr>
            <a:xfrm>
              <a:off x="1835280" y="1125360"/>
              <a:ext cx="576000" cy="15681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</p:grpSp>
      <p:sp>
        <p:nvSpPr>
          <p:cNvPr id="49" name=""/>
          <p:cNvSpPr/>
          <p:nvPr/>
        </p:nvSpPr>
        <p:spPr>
          <a:xfrm>
            <a:off x="612360" y="1900080"/>
            <a:ext cx="471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+/+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432360" y="3500280"/>
            <a:ext cx="73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Times New Roman"/>
              </a:rPr>
              <a:t>+/</a:t>
            </a:r>
            <a:r>
              <a:rPr b="1" i="1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i="1" lang="en-US" sz="1400" spc="-1" strike="noStrike">
                <a:solidFill>
                  <a:srgbClr val="000000"/>
                </a:solidFill>
                <a:latin typeface="Verdana"/>
              </a:rPr>
              <a:t>ex2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104760" y="4869000"/>
            <a:ext cx="110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s-ES" sz="14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i="1" lang="es-ES" sz="1400" spc="-1" strike="noStrike">
                <a:solidFill>
                  <a:srgbClr val="000000"/>
                </a:solidFill>
                <a:latin typeface="Verdana"/>
              </a:rPr>
              <a:t>ex2/ </a:t>
            </a:r>
            <a:r>
              <a:rPr b="1" i="1" lang="es-ES" sz="14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i="1" lang="es-ES" sz="1400" spc="-1" strike="noStrike">
                <a:solidFill>
                  <a:srgbClr val="000000"/>
                </a:solidFill>
                <a:latin typeface="Verdana"/>
              </a:rPr>
              <a:t>ex2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1400760" y="5900760"/>
            <a:ext cx="768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s-ES" sz="1600" spc="-1" strike="noStrike">
                <a:solidFill>
                  <a:srgbClr val="000000"/>
                </a:solidFill>
                <a:latin typeface="Verdana"/>
              </a:rPr>
              <a:t>Birc1F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2698920" y="5900760"/>
            <a:ext cx="599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s-ES" sz="1600" spc="-1" strike="noStrike">
                <a:solidFill>
                  <a:srgbClr val="000000"/>
                </a:solidFill>
                <a:latin typeface="Verdana"/>
              </a:rPr>
              <a:t>Renl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 rot="16200000">
            <a:off x="1010160" y="691560"/>
            <a:ext cx="660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Verdana"/>
              </a:rPr>
              <a:t>input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 rot="16200000">
            <a:off x="2030760" y="767160"/>
            <a:ext cx="493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Verdana"/>
              </a:rPr>
              <a:t>IgG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 rot="16200000">
            <a:off x="1776240" y="643320"/>
            <a:ext cx="650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Verdana"/>
              </a:rPr>
              <a:t>TFII-I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 rot="16200000">
            <a:off x="2343960" y="691560"/>
            <a:ext cx="660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Verdana"/>
              </a:rPr>
              <a:t>input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 rot="16200000">
            <a:off x="3183480" y="767160"/>
            <a:ext cx="493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Verdana"/>
              </a:rPr>
              <a:t>IgG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 rot="16200000">
            <a:off x="2947680" y="645480"/>
            <a:ext cx="650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Verdana"/>
              </a:rPr>
              <a:t>TFII-I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246600" y="200160"/>
            <a:ext cx="390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Verdana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1" name="" descr=""/>
          <p:cNvPicPr/>
          <p:nvPr/>
        </p:nvPicPr>
        <p:blipFill>
          <a:blip r:embed="rId8"/>
          <a:stretch/>
        </p:blipFill>
        <p:spPr>
          <a:xfrm>
            <a:off x="5867280" y="1771560"/>
            <a:ext cx="2309760" cy="649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pSp>
        <p:nvGrpSpPr>
          <p:cNvPr id="62" name=""/>
          <p:cNvGrpSpPr/>
          <p:nvPr/>
        </p:nvGrpSpPr>
        <p:grpSpPr>
          <a:xfrm>
            <a:off x="4577400" y="2492280"/>
            <a:ext cx="2872800" cy="1900440"/>
            <a:chOff x="4577400" y="2492280"/>
            <a:chExt cx="2872800" cy="1900440"/>
          </a:xfrm>
        </p:grpSpPr>
        <p:sp>
          <p:nvSpPr>
            <p:cNvPr id="63" name=""/>
            <p:cNvSpPr/>
            <p:nvPr/>
          </p:nvSpPr>
          <p:spPr>
            <a:xfrm>
              <a:off x="5445000" y="3419640"/>
              <a:ext cx="289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4577400" y="2922480"/>
              <a:ext cx="852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Verdana"/>
                </a:rPr>
                <a:t>TFIIGST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5433840" y="3098880"/>
              <a:ext cx="289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6639480" y="2495520"/>
              <a:ext cx="754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Verdana"/>
                </a:rPr>
                <a:t>+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/</a:t>
              </a:r>
              <a:r>
                <a:rPr b="1" lang="en-US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lang="en-US" sz="1400" spc="-1" strike="noStrike">
                  <a:solidFill>
                    <a:srgbClr val="000000"/>
                  </a:solidFill>
                  <a:latin typeface="Verdana"/>
                </a:rPr>
                <a:t>ex2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6004080" y="2492280"/>
              <a:ext cx="457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Verdana"/>
                </a:rPr>
                <a:t>+/+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68" name="" descr=""/>
            <p:cNvPicPr/>
            <p:nvPr/>
          </p:nvPicPr>
          <p:blipFill>
            <a:blip r:embed="rId9"/>
            <a:stretch/>
          </p:blipFill>
          <p:spPr>
            <a:xfrm>
              <a:off x="5865840" y="2811600"/>
              <a:ext cx="1584360" cy="15811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69" name=""/>
            <p:cNvSpPr/>
            <p:nvPr/>
          </p:nvSpPr>
          <p:spPr>
            <a:xfrm>
              <a:off x="4850280" y="3289320"/>
              <a:ext cx="650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Verdana"/>
                </a:rPr>
                <a:t>TFII-I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70" name=""/>
          <p:cNvSpPr/>
          <p:nvPr/>
        </p:nvSpPr>
        <p:spPr>
          <a:xfrm>
            <a:off x="4491000" y="1828800"/>
            <a:ext cx="13543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Verdana"/>
              </a:rPr>
              <a:t>IP: V5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Verdana"/>
              </a:rPr>
              <a:t>Western: GST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 rot="16200000">
            <a:off x="5902920" y="1387800"/>
            <a:ext cx="493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Verdana"/>
              </a:rPr>
              <a:t>IgG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 rot="16200000">
            <a:off x="5883480" y="842040"/>
            <a:ext cx="12931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Verdana"/>
              </a:rPr>
              <a:t>Input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Verdana"/>
              </a:rPr>
              <a:t>TFIIGST/TFIIV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 rot="16200000">
            <a:off x="6325920" y="914040"/>
            <a:ext cx="13831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Verdana"/>
              </a:rPr>
              <a:t>IP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Verdana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TFIIGST/TFIIV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 rot="16200000">
            <a:off x="7205400" y="799920"/>
            <a:ext cx="1386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Verdana"/>
              </a:rPr>
              <a:t>IP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Verdana"/>
              </a:rPr>
              <a:t>TFIIGST/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en-US" sz="1200" spc="-1" strike="noStrike">
                <a:solidFill>
                  <a:srgbClr val="000000"/>
                </a:solidFill>
                <a:latin typeface="Verdana"/>
              </a:rPr>
              <a:t>TFIIV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 rot="16200000">
            <a:off x="6749280" y="731520"/>
            <a:ext cx="1434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Verdana"/>
              </a:rPr>
              <a:t>Input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Verdana"/>
              </a:rPr>
              <a:t>TFII-GST/</a:t>
            </a:r>
            <a:r>
              <a:rPr b="1" lang="es-ES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es-ES" sz="1200" spc="-1" strike="noStrike">
                <a:solidFill>
                  <a:srgbClr val="000000"/>
                </a:solidFill>
                <a:latin typeface="Verdana"/>
              </a:rPr>
              <a:t>TFIIV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4082760" y="260280"/>
            <a:ext cx="3848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Verdana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4082400" y="4365720"/>
            <a:ext cx="374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Verdana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78" name=""/>
          <p:cNvGrpSpPr/>
          <p:nvPr/>
        </p:nvGrpSpPr>
        <p:grpSpPr>
          <a:xfrm>
            <a:off x="4727160" y="4569480"/>
            <a:ext cx="4030920" cy="1955160"/>
            <a:chOff x="4727160" y="4569480"/>
            <a:chExt cx="4030920" cy="1955160"/>
          </a:xfrm>
        </p:grpSpPr>
        <p:sp>
          <p:nvSpPr>
            <p:cNvPr id="79" name=""/>
            <p:cNvSpPr/>
            <p:nvPr/>
          </p:nvSpPr>
          <p:spPr>
            <a:xfrm rot="16200000">
              <a:off x="5902920" y="4785120"/>
              <a:ext cx="493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400" spc="-1" strike="noStrike">
                  <a:solidFill>
                    <a:srgbClr val="000000"/>
                  </a:solidFill>
                  <a:latin typeface="Verdana"/>
                </a:rPr>
                <a:t>IgG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7403760" y="5383080"/>
              <a:ext cx="135432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400" spc="-1" strike="noStrike">
                  <a:solidFill>
                    <a:srgbClr val="000000"/>
                  </a:solidFill>
                  <a:latin typeface="Verdana"/>
                </a:rPr>
                <a:t>IP: V5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400" spc="-1" strike="noStrike">
                  <a:solidFill>
                    <a:srgbClr val="000000"/>
                  </a:solidFill>
                  <a:latin typeface="Verdana"/>
                </a:rPr>
                <a:t>Western: GST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4727160" y="5456160"/>
              <a:ext cx="1032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Verdana"/>
                </a:rPr>
                <a:t>PARP-GST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 rot="19394400">
              <a:off x="6427080" y="4790880"/>
              <a:ext cx="740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Verdana"/>
                </a:rPr>
                <a:t>TFIIV5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 rot="19431000">
              <a:off x="6822720" y="4790520"/>
              <a:ext cx="8499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lang="en-US" sz="1400" spc="-1" strike="noStrike">
                  <a:solidFill>
                    <a:srgbClr val="000000"/>
                  </a:solidFill>
                  <a:latin typeface="Verdana"/>
                </a:rPr>
                <a:t>TFIIV5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84" name="" descr=""/>
            <p:cNvPicPr/>
            <p:nvPr/>
          </p:nvPicPr>
          <p:blipFill>
            <a:blip r:embed="rId10"/>
            <a:stretch/>
          </p:blipFill>
          <p:spPr>
            <a:xfrm>
              <a:off x="5867280" y="5240160"/>
              <a:ext cx="1440000" cy="792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85" name="" descr=""/>
            <p:cNvPicPr/>
            <p:nvPr/>
          </p:nvPicPr>
          <p:blipFill>
            <a:blip r:embed="rId11"/>
            <a:stretch/>
          </p:blipFill>
          <p:spPr>
            <a:xfrm>
              <a:off x="6156360" y="6032520"/>
              <a:ext cx="1154160" cy="4921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86" name=""/>
            <p:cNvSpPr/>
            <p:nvPr/>
          </p:nvSpPr>
          <p:spPr>
            <a:xfrm>
              <a:off x="7396200" y="6103800"/>
              <a:ext cx="1241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400" spc="-1" strike="noStrike">
                  <a:solidFill>
                    <a:srgbClr val="000000"/>
                  </a:solidFill>
                  <a:latin typeface="Verdana"/>
                </a:rPr>
                <a:t>Western: V5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04T11:48:04Z</dcterms:created>
  <dc:creator>U26211</dc:creator>
  <dc:description/>
  <dc:language>en-US</dc:language>
  <cp:lastModifiedBy> </cp:lastModifiedBy>
  <dcterms:modified xsi:type="dcterms:W3CDTF">2010-04-09T10:25:42Z</dcterms:modified>
  <cp:revision>6</cp:revision>
  <dc:subject/>
  <dc:title>Presentación de PowerPoint</dc:title>
</cp:coreProperties>
</file>